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0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132" autoAdjust="0"/>
    <p:restoredTop sz="93738" autoAdjust="0"/>
  </p:normalViewPr>
  <p:slideViewPr>
    <p:cSldViewPr snapToGrid="0">
      <p:cViewPr varScale="1">
        <p:scale>
          <a:sx n="45" d="100"/>
          <a:sy n="45" d="100"/>
        </p:scale>
        <p:origin x="13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14431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04164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3529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32239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8219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82183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52106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48702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05300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47235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89269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44411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601149C8-6421-48C6-A6F0-699DADD852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6457" y="1315354"/>
            <a:ext cx="3286153" cy="439420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E32AAFB-B41D-429A-92B2-2A7D75396AF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9770" y="1315354"/>
            <a:ext cx="3286153" cy="4394201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A79B8FE-3B32-485F-94CD-3FCBE36C4CE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6174" y="1315353"/>
            <a:ext cx="3286154" cy="439420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D210CFB-9C1F-4E37-84E3-06EE8EAEB31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9770" y="5921829"/>
            <a:ext cx="3286153" cy="43942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FA000BDB-DC13-47EE-8E37-7762D1799E5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6457" y="5930899"/>
            <a:ext cx="3286153" cy="439420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07927933-9080-451E-8035-26208641C4C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6174" y="5921828"/>
            <a:ext cx="3286153" cy="4394201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15BE5B57-581A-4432-A6ED-A8E4D92E5902}"/>
              </a:ext>
            </a:extLst>
          </p:cNvPr>
          <p:cNvSpPr/>
          <p:nvPr/>
        </p:nvSpPr>
        <p:spPr>
          <a:xfrm>
            <a:off x="939770" y="10546444"/>
            <a:ext cx="10122840" cy="11440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3. CD45-positive cells are present within  wounded skin of mice received GFP-labeled, M-CSF-cultured myeloid cells. 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rmal sections from the wounds of mice received M-CSF-cultured myeloid cells 4 weeks post injury, were stained with CD45 antibody (red). DAPI (blue) was used as a nuclear counterstain. Scale bars in all images were 50 µm. Squares at left bottom panel were magnified and shown on the middle and right bottom panels. 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221B24A8-8881-42D8-8D8C-3695687007F1}"/>
              </a:ext>
            </a:extLst>
          </p:cNvPr>
          <p:cNvCxnSpPr>
            <a:cxnSpLocks/>
          </p:cNvCxnSpPr>
          <p:nvPr/>
        </p:nvCxnSpPr>
        <p:spPr>
          <a:xfrm>
            <a:off x="10414002" y="10160000"/>
            <a:ext cx="47171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6CC8A5EC-47A8-4EA2-AB36-E6ED146D77FD}"/>
              </a:ext>
            </a:extLst>
          </p:cNvPr>
          <p:cNvCxnSpPr>
            <a:cxnSpLocks/>
          </p:cNvCxnSpPr>
          <p:nvPr/>
        </p:nvCxnSpPr>
        <p:spPr>
          <a:xfrm>
            <a:off x="7053945" y="10160000"/>
            <a:ext cx="47171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390BAF12-1AE4-442A-A492-F76DE45D21E3}"/>
              </a:ext>
            </a:extLst>
          </p:cNvPr>
          <p:cNvCxnSpPr>
            <a:cxnSpLocks/>
          </p:cNvCxnSpPr>
          <p:nvPr/>
        </p:nvCxnSpPr>
        <p:spPr>
          <a:xfrm>
            <a:off x="10414002" y="5537200"/>
            <a:ext cx="47171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37AFF45F-54B7-4A57-A6D8-A4BC3A9CE968}"/>
              </a:ext>
            </a:extLst>
          </p:cNvPr>
          <p:cNvCxnSpPr>
            <a:cxnSpLocks/>
          </p:cNvCxnSpPr>
          <p:nvPr/>
        </p:nvCxnSpPr>
        <p:spPr>
          <a:xfrm>
            <a:off x="7053945" y="5529943"/>
            <a:ext cx="47171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04666686-123F-4EB7-BFE4-71D5A1045ED7}"/>
              </a:ext>
            </a:extLst>
          </p:cNvPr>
          <p:cNvCxnSpPr>
            <a:cxnSpLocks/>
          </p:cNvCxnSpPr>
          <p:nvPr/>
        </p:nvCxnSpPr>
        <p:spPr>
          <a:xfrm>
            <a:off x="3643087" y="5493657"/>
            <a:ext cx="47171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96D38702-F0D3-4700-84AC-C6634629556A}"/>
              </a:ext>
            </a:extLst>
          </p:cNvPr>
          <p:cNvCxnSpPr>
            <a:cxnSpLocks/>
          </p:cNvCxnSpPr>
          <p:nvPr/>
        </p:nvCxnSpPr>
        <p:spPr>
          <a:xfrm>
            <a:off x="3733801" y="10160000"/>
            <a:ext cx="235856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5A66EE7B-F3F7-4FDB-83FD-D872E6005ECC}"/>
              </a:ext>
            </a:extLst>
          </p:cNvPr>
          <p:cNvSpPr txBox="1"/>
          <p:nvPr/>
        </p:nvSpPr>
        <p:spPr>
          <a:xfrm>
            <a:off x="1698171" y="7053943"/>
            <a:ext cx="1640115" cy="21626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CA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7A09C55-0625-419F-9E32-9F49A841F51A}"/>
              </a:ext>
            </a:extLst>
          </p:cNvPr>
          <p:cNvSpPr txBox="1"/>
          <p:nvPr/>
        </p:nvSpPr>
        <p:spPr>
          <a:xfrm>
            <a:off x="2590294" y="7244446"/>
            <a:ext cx="1640115" cy="21626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4088155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0</TotalTime>
  <Words>80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nyuan</dc:creator>
  <cp:lastModifiedBy>chn off31</cp:lastModifiedBy>
  <cp:revision>65</cp:revision>
  <dcterms:created xsi:type="dcterms:W3CDTF">2018-08-16T19:41:08Z</dcterms:created>
  <dcterms:modified xsi:type="dcterms:W3CDTF">2022-06-15T08:49:42Z</dcterms:modified>
</cp:coreProperties>
</file>